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9" r:id="rId2"/>
    <p:sldId id="257" r:id="rId3"/>
    <p:sldId id="258" r:id="rId4"/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ypro Ruby - Proteins" id="{4A079556-66AE-AA47-A7CA-8E71EB58C09A}">
          <p14:sldIdLst>
            <p14:sldId id="259"/>
          </p14:sldIdLst>
        </p14:section>
        <p14:section name="Nile red - lipids" id="{11708C25-A7BD-0E40-AA00-A18DF93AD749}">
          <p14:sldIdLst>
            <p14:sldId id="257"/>
          </p14:sldIdLst>
        </p14:section>
        <p14:section name="PI - eDNA" id="{2EFDAC3C-D61A-B24A-A23C-C5BFB87D6D19}">
          <p14:sldIdLst>
            <p14:sldId id="258"/>
          </p14:sldIdLst>
        </p14:section>
        <p14:section name="Alexa Flour 674 - CHO" id="{0B43956C-776A-7E44-A68B-288B6AF0AC98}">
          <p14:sldIdLst>
            <p14:sldId id="256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ja Dokic (PhD Biosciences FT)" initials="AD(BF" lastIdx="2" clrIdx="0">
    <p:extLst>
      <p:ext uri="{19B8F6BF-5375-455C-9EA6-DF929625EA0E}">
        <p15:presenceInfo xmlns:p15="http://schemas.microsoft.com/office/powerpoint/2012/main" userId="S::axd671@student.bham.ac.uk::535e425a-9a10-4e7c-9f9e-f4f408b62797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08"/>
    <p:restoredTop sz="94608"/>
  </p:normalViewPr>
  <p:slideViewPr>
    <p:cSldViewPr snapToGrid="0" snapToObjects="1">
      <p:cViewPr varScale="1">
        <p:scale>
          <a:sx n="95" d="100"/>
          <a:sy n="95" d="100"/>
        </p:scale>
        <p:origin x="58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E29474-E72D-6947-8AF1-8D156DB37BC8}" type="datetimeFigureOut">
              <a:rPr lang="en-US" smtClean="0"/>
              <a:t>2/23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2AA45C-8058-ED44-9B24-829F259A81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7704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4C491B-3960-5A42-BDCF-5F5CAA37E23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33A31A2-D5FB-A246-91EA-ED3482FBA0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9463D6-3D7F-E443-A18B-59F930113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EA904-0D95-6843-9723-20B6A05AD1E8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34A0F2-AC02-BE4D-AD70-E508D7182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0B4556-2A20-824A-B98E-B064694A3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5453D-1A62-6441-B4AA-697EEA684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0671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5C86F4-4F6E-6D40-9E4C-E1BC942786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A74FC3-1325-864D-92BC-BA1E0F5B1C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0D563F-0AEB-AF4A-8F4B-F2C843CB61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EA904-0D95-6843-9723-20B6A05AD1E8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50DB68-7DE3-644C-8821-1134B5113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C8216F-0123-1E4B-9C92-24D76F049F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5453D-1A62-6441-B4AA-697EEA684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57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998CB16-3397-124E-8F35-E68A5C290E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E6B950-197B-654C-883D-B2C4A7837A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CBBF8D-24EF-D343-8FB3-4AF5DA784B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EA904-0D95-6843-9723-20B6A05AD1E8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AD7FB7-2712-C341-91D5-7E0E8E30AF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B0AB37-63E2-7E40-846B-A7C6A02F04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5453D-1A62-6441-B4AA-697EEA684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030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F36467-2255-AF41-BA3B-C71616615C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EE1B1F-FE16-3A42-9BAB-663270F412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AEA655-CFFC-3140-AD4D-7F63913172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EA904-0D95-6843-9723-20B6A05AD1E8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9CD6E9-FABB-6D41-BC78-D2F9EB07C5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E8A8BC-676F-484C-8FBC-DC505A4CD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5453D-1A62-6441-B4AA-697EEA684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894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C6D3AD-C48F-3B47-ACCE-C5F374872C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66E93E-9A05-F44E-BDFF-FB4A7D4B6F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61EF4B-93CE-FA4A-9C16-77EF12FC57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EA904-0D95-6843-9723-20B6A05AD1E8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41D84C-9747-C749-BD82-4B998A12D5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A6F464-6719-A543-99B4-47C9AA276D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5453D-1A62-6441-B4AA-697EEA684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864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2C772D-B0B5-FD4F-81F2-8ECCF97660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837E8A-2BD5-BD41-BF1D-AD5D8645A3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B1E185-242B-964C-8F59-EEE2E42A84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60DE46-7FE8-AB46-881F-18153D2D9C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EA904-0D95-6843-9723-20B6A05AD1E8}" type="datetimeFigureOut">
              <a:rPr lang="en-US" smtClean="0"/>
              <a:t>2/2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11A018-8617-CB4B-A5E7-6A76DE0903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2E7AB5-4ED0-EC4C-A194-15A98933E0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5453D-1A62-6441-B4AA-697EEA684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284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9458BE-998C-4A45-A468-3AD14C22CC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35AFCD-C306-5C47-A9FF-FE41E55E1F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C79455-3487-9642-9E0F-46F39F7CC7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4869341-A59C-3349-B572-A22B518557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A3C108A-332A-A146-9CFE-A0F6D57A65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A81157B-E884-9C4B-8DAA-328482982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EA904-0D95-6843-9723-20B6A05AD1E8}" type="datetimeFigureOut">
              <a:rPr lang="en-US" smtClean="0"/>
              <a:t>2/23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79A51C-4A25-A64B-8BC4-800D808F0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10B0997-4CC4-5544-87E8-EEDB4D48DC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5453D-1A62-6441-B4AA-697EEA684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375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46D3BF-0E1F-984A-A5C9-F2E72E8F94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1CDAF8-3DF0-1942-ABE1-2AC4CB42C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EA904-0D95-6843-9723-20B6A05AD1E8}" type="datetimeFigureOut">
              <a:rPr lang="en-US" smtClean="0"/>
              <a:t>2/23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5468A64-5EC4-7B4D-8012-F3D47830A9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83627B-DC0B-5941-A9C0-59D9A0E742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5453D-1A62-6441-B4AA-697EEA684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8557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715D6DA-ADB7-114D-BA54-123E8294E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EA904-0D95-6843-9723-20B6A05AD1E8}" type="datetimeFigureOut">
              <a:rPr lang="en-US" smtClean="0"/>
              <a:t>2/23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564CBFD-40C9-C440-B769-7B69AD079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1EA1D26-9BD0-9446-BEBC-ECE214A09E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5453D-1A62-6441-B4AA-697EEA684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792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963F9F-A1D2-5E47-83DE-FB32D10B3B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1A5DB9-C6EC-614D-ADF1-9B5FEBAE68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C6A49A-6CDF-794C-86E4-065317BB5A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7F9A54-729A-364D-984E-301E312790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EA904-0D95-6843-9723-20B6A05AD1E8}" type="datetimeFigureOut">
              <a:rPr lang="en-US" smtClean="0"/>
              <a:t>2/2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463C31-1525-E44F-8C37-1540C2249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910FC3-ECE7-CB44-9459-2BCFB9A04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5453D-1A62-6441-B4AA-697EEA684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3403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F4E5B3-A1CB-8A4A-AC44-9E3A56E3F9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D032E59-D75F-7C4A-9E5C-D145C26135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848F0A0-2D14-0545-A836-A835AC2B5F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251651-C43E-EE46-817B-3302C1E8A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8EA904-0D95-6843-9723-20B6A05AD1E8}" type="datetimeFigureOut">
              <a:rPr lang="en-US" smtClean="0"/>
              <a:t>2/2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B76AA3-CDB7-9C4B-BAF1-89C226EEA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A2C170-9521-914E-A7F6-66C231B68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5453D-1A62-6441-B4AA-697EEA684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1362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F676204-A8BA-1E43-A380-DD1A07F875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99A7B3-809D-9D4D-8D87-EFBA29829C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620D00-47C7-C145-8BD8-D99B5CFEC1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8EA904-0D95-6843-9723-20B6A05AD1E8}" type="datetimeFigureOut">
              <a:rPr lang="en-US" smtClean="0"/>
              <a:t>2/2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9DF348-B782-5F4E-ADA0-7BB049F2B4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8754A8-9B26-8B47-A682-D2802E7421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65453D-1A62-6441-B4AA-697EEA6844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327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g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g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g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cture containing grass, green, sitting, animal&#10;&#10;Description automatically generated">
            <a:extLst>
              <a:ext uri="{FF2B5EF4-FFF2-40B4-BE49-F238E27FC236}">
                <a16:creationId xmlns:a16="http://schemas.microsoft.com/office/drawing/2014/main" id="{BB68A1FD-2DC6-114F-BD95-D94051DF88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4128" y="177800"/>
            <a:ext cx="6502400" cy="65024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5EAD747-F55C-1648-BF77-600C4D4539CE}"/>
              </a:ext>
            </a:extLst>
          </p:cNvPr>
          <p:cNvSpPr txBox="1"/>
          <p:nvPr/>
        </p:nvSpPr>
        <p:spPr>
          <a:xfrm>
            <a:off x="7199175" y="177800"/>
            <a:ext cx="4421325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/>
            <a:r>
              <a:rPr lang="en-GB" b="1" dirty="0"/>
              <a:t>Binarized image of a confocal z-stack (20</a:t>
            </a:r>
            <a:r>
              <a:rPr lang="el-GR" b="1" dirty="0">
                <a:solidFill>
                  <a:schemeClr val="dk1"/>
                </a:solidFill>
              </a:rPr>
              <a:t>μ</a:t>
            </a:r>
            <a:r>
              <a:rPr lang="en-GB" b="1" dirty="0">
                <a:solidFill>
                  <a:schemeClr val="dk1"/>
                </a:solidFill>
              </a:rPr>
              <a:t>m</a:t>
            </a:r>
            <a:r>
              <a:rPr lang="en-GB" b="1" dirty="0"/>
              <a:t>) 6-day old eGFP-expressing </a:t>
            </a:r>
            <a:r>
              <a:rPr lang="en-GB" b="1" i="1" dirty="0"/>
              <a:t>M. abscessus</a:t>
            </a:r>
            <a:r>
              <a:rPr lang="en-GB" b="1" dirty="0"/>
              <a:t> biofilm stained with Sypro. </a:t>
            </a:r>
            <a:r>
              <a:rPr lang="en-GB" dirty="0"/>
              <a:t>With the aim of showing the the bacilli (green) and  proteins (red) sectoring, a 20</a:t>
            </a:r>
            <a:r>
              <a:rPr lang="el-GR" dirty="0">
                <a:solidFill>
                  <a:schemeClr val="dk1"/>
                </a:solidFill>
              </a:rPr>
              <a:t>μ</a:t>
            </a:r>
            <a:r>
              <a:rPr lang="en-GB" dirty="0">
                <a:solidFill>
                  <a:schemeClr val="dk1"/>
                </a:solidFill>
              </a:rPr>
              <a:t>m confocal stack was binarized. Darker red dots are representative of the proteins in the ECM, and the background red grains are a consequence of </a:t>
            </a:r>
            <a:r>
              <a:rPr lang="en-GB">
                <a:solidFill>
                  <a:schemeClr val="dk1"/>
                </a:solidFill>
              </a:rPr>
              <a:t>the binarization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4506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large crowd of people&#10;&#10;Description automatically generated">
            <a:extLst>
              <a:ext uri="{FF2B5EF4-FFF2-40B4-BE49-F238E27FC236}">
                <a16:creationId xmlns:a16="http://schemas.microsoft.com/office/drawing/2014/main" id="{CD7FD733-3AE1-4642-9885-0B08D7FBC3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1381" y="177800"/>
            <a:ext cx="6502400" cy="65024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163404D-2034-384D-9EA3-BF188D6832A1}"/>
              </a:ext>
            </a:extLst>
          </p:cNvPr>
          <p:cNvSpPr txBox="1"/>
          <p:nvPr/>
        </p:nvSpPr>
        <p:spPr>
          <a:xfrm>
            <a:off x="7199175" y="177800"/>
            <a:ext cx="4421325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/>
            <a:r>
              <a:rPr lang="en-GB" b="1" dirty="0"/>
              <a:t>Binarized image of a confocal z-stack (10</a:t>
            </a:r>
            <a:r>
              <a:rPr lang="el-GR" b="1" dirty="0">
                <a:solidFill>
                  <a:schemeClr val="dk1"/>
                </a:solidFill>
              </a:rPr>
              <a:t>μ</a:t>
            </a:r>
            <a:r>
              <a:rPr lang="en-GB" b="1" dirty="0">
                <a:solidFill>
                  <a:schemeClr val="dk1"/>
                </a:solidFill>
              </a:rPr>
              <a:t>m</a:t>
            </a:r>
            <a:r>
              <a:rPr lang="en-GB" b="1" dirty="0"/>
              <a:t>) 6-day old eGFP-expressing </a:t>
            </a:r>
            <a:r>
              <a:rPr lang="en-GB" b="1" i="1" dirty="0"/>
              <a:t>M. abscessus</a:t>
            </a:r>
            <a:r>
              <a:rPr lang="en-GB" b="1" dirty="0"/>
              <a:t> biofilm stained with Nile Red. </a:t>
            </a:r>
            <a:r>
              <a:rPr lang="en-GB" dirty="0"/>
              <a:t>With the aim of showing the the bacilli (green) and  lipids (red) sectoring, a 10</a:t>
            </a:r>
            <a:r>
              <a:rPr lang="el-GR" dirty="0">
                <a:solidFill>
                  <a:schemeClr val="dk1"/>
                </a:solidFill>
              </a:rPr>
              <a:t>μ</a:t>
            </a:r>
            <a:r>
              <a:rPr lang="en-GB" dirty="0">
                <a:solidFill>
                  <a:schemeClr val="dk1"/>
                </a:solidFill>
              </a:rPr>
              <a:t>m confocal stack was binarized. Yellow and orange indicate overlap of the lipids and bacterial cells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252613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grass, green, rain, dark&#10;&#10;Description automatically generated">
            <a:extLst>
              <a:ext uri="{FF2B5EF4-FFF2-40B4-BE49-F238E27FC236}">
                <a16:creationId xmlns:a16="http://schemas.microsoft.com/office/drawing/2014/main" id="{419AAAE8-3A4C-F545-8355-BA4CAF4756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864" y="177800"/>
            <a:ext cx="6502400" cy="65024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D2BEF9D-0FB9-CF43-9636-F5AD7209A969}"/>
              </a:ext>
            </a:extLst>
          </p:cNvPr>
          <p:cNvSpPr txBox="1"/>
          <p:nvPr/>
        </p:nvSpPr>
        <p:spPr>
          <a:xfrm>
            <a:off x="7199175" y="177800"/>
            <a:ext cx="4421325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/>
            <a:r>
              <a:rPr lang="en-GB" b="1" dirty="0"/>
              <a:t>Binarized image of a confocal z-stack (20</a:t>
            </a:r>
            <a:r>
              <a:rPr lang="el-GR" b="1" dirty="0">
                <a:solidFill>
                  <a:schemeClr val="dk1"/>
                </a:solidFill>
              </a:rPr>
              <a:t>μ</a:t>
            </a:r>
            <a:r>
              <a:rPr lang="en-GB" b="1" dirty="0">
                <a:solidFill>
                  <a:schemeClr val="dk1"/>
                </a:solidFill>
              </a:rPr>
              <a:t>m</a:t>
            </a:r>
            <a:r>
              <a:rPr lang="en-GB" b="1" dirty="0"/>
              <a:t>) 6-day old eGFP-expressing </a:t>
            </a:r>
            <a:r>
              <a:rPr lang="en-GB" b="1" i="1" dirty="0"/>
              <a:t>M. abscessus</a:t>
            </a:r>
            <a:r>
              <a:rPr lang="en-GB" b="1" dirty="0"/>
              <a:t> biofilm stained with Propidium Iodide. </a:t>
            </a:r>
            <a:r>
              <a:rPr lang="en-GB" dirty="0"/>
              <a:t>With the aim of showing the the bacilli (green) and  eDNA (red) sectoring, a 20</a:t>
            </a:r>
            <a:r>
              <a:rPr lang="el-GR" dirty="0">
                <a:solidFill>
                  <a:schemeClr val="dk1"/>
                </a:solidFill>
              </a:rPr>
              <a:t>μ</a:t>
            </a:r>
            <a:r>
              <a:rPr lang="en-GB" dirty="0">
                <a:solidFill>
                  <a:schemeClr val="dk1"/>
                </a:solidFill>
              </a:rPr>
              <a:t>m confocal stack was binarized. Red dots are representative of the eDNA spread throughout the ECM of the biofilm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132097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picture containing green, grass, rain, lush&#10;&#10;Description automatically generated">
            <a:extLst>
              <a:ext uri="{FF2B5EF4-FFF2-40B4-BE49-F238E27FC236}">
                <a16:creationId xmlns:a16="http://schemas.microsoft.com/office/drawing/2014/main" id="{60F4CE6E-87E3-7945-860B-05808F2DF4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2370" y="177800"/>
            <a:ext cx="6502400" cy="65024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19312FF-25E6-0040-AE90-5F5E036956D4}"/>
              </a:ext>
            </a:extLst>
          </p:cNvPr>
          <p:cNvSpPr txBox="1"/>
          <p:nvPr/>
        </p:nvSpPr>
        <p:spPr>
          <a:xfrm>
            <a:off x="7039155" y="177800"/>
            <a:ext cx="4421325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/>
            <a:r>
              <a:rPr lang="en-GB" b="1" dirty="0"/>
              <a:t>Binarized image of a confocal z-stack (20</a:t>
            </a:r>
            <a:r>
              <a:rPr lang="el-GR" b="1" dirty="0">
                <a:solidFill>
                  <a:schemeClr val="dk1"/>
                </a:solidFill>
              </a:rPr>
              <a:t>μ</a:t>
            </a:r>
            <a:r>
              <a:rPr lang="en-GB" b="1" dirty="0">
                <a:solidFill>
                  <a:schemeClr val="dk1"/>
                </a:solidFill>
              </a:rPr>
              <a:t>m</a:t>
            </a:r>
            <a:r>
              <a:rPr lang="en-GB" b="1" dirty="0"/>
              <a:t>) 6-day old eGFP-expressing </a:t>
            </a:r>
            <a:r>
              <a:rPr lang="en-GB" b="1" i="1" dirty="0"/>
              <a:t>M. abscessus</a:t>
            </a:r>
            <a:r>
              <a:rPr lang="en-GB" b="1" dirty="0"/>
              <a:t> biofilm stained with </a:t>
            </a:r>
            <a:r>
              <a:rPr lang="en-GB" b="1" dirty="0" err="1"/>
              <a:t>AlexaFlour</a:t>
            </a:r>
            <a:r>
              <a:rPr lang="en-GB" b="1" dirty="0"/>
              <a:t>. </a:t>
            </a:r>
            <a:r>
              <a:rPr lang="en-GB" dirty="0"/>
              <a:t>With the aim of showing the the bacilli (green) and  carbohydrates (red) sectoring, a 20</a:t>
            </a:r>
            <a:r>
              <a:rPr lang="el-GR" dirty="0">
                <a:solidFill>
                  <a:schemeClr val="dk1"/>
                </a:solidFill>
              </a:rPr>
              <a:t>μ</a:t>
            </a:r>
            <a:r>
              <a:rPr lang="en-GB" dirty="0">
                <a:solidFill>
                  <a:schemeClr val="dk1"/>
                </a:solidFill>
              </a:rPr>
              <a:t>m confocal stack was binarized. Red dots indicate carbohydrates that are sparce throughout the biofilm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3499449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60</Words>
  <Application>Microsoft Macintosh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ja Dokic (PhD Biosciences FT)</dc:creator>
  <cp:lastModifiedBy>Anja Dokic (PhD Biosciences FT)</cp:lastModifiedBy>
  <cp:revision>3</cp:revision>
  <dcterms:created xsi:type="dcterms:W3CDTF">2020-12-22T17:11:42Z</dcterms:created>
  <dcterms:modified xsi:type="dcterms:W3CDTF">2021-02-23T14:10:34Z</dcterms:modified>
</cp:coreProperties>
</file>